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14403388"/>
  <p:notesSz cx="7102475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40BA4F-CEBC-4B87-9778-AD7B920934C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576000"/>
            <a:ext cx="8229600" cy="24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3360240"/>
            <a:ext cx="822960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8324640"/>
            <a:ext cx="822960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D99E70-62C5-40F1-A13A-38FA7A285F7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576000"/>
            <a:ext cx="8229600" cy="24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3360240"/>
            <a:ext cx="401580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3360240"/>
            <a:ext cx="401580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8324640"/>
            <a:ext cx="401580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8324640"/>
            <a:ext cx="401580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5E0339-73C8-4348-952D-EEF38189444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576000"/>
            <a:ext cx="8229600" cy="24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3360240"/>
            <a:ext cx="264960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3360240"/>
            <a:ext cx="264960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3360240"/>
            <a:ext cx="264960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8324640"/>
            <a:ext cx="264960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8324640"/>
            <a:ext cx="264960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8324640"/>
            <a:ext cx="264960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59A9D7-052C-4033-BF02-0184E13D26D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576000"/>
            <a:ext cx="8229600" cy="24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3360240"/>
            <a:ext cx="8229600" cy="9504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E0FFC5-5274-4D80-8D36-1655BD35A84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576000"/>
            <a:ext cx="8229600" cy="24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3360240"/>
            <a:ext cx="8229600" cy="9504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607262-DBA8-466B-9030-59AADE5DEBB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576000"/>
            <a:ext cx="8229600" cy="24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3360240"/>
            <a:ext cx="4015800" cy="9504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3360240"/>
            <a:ext cx="4015800" cy="9504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16314B-BE63-43D8-9FBF-F84F0790E69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576000"/>
            <a:ext cx="8229600" cy="24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15DC5F-7478-4B36-90CA-CBC2D8E8D00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576000"/>
            <a:ext cx="8229600" cy="11126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FEDF51-F1B8-4D36-AF9C-E506E229B47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576000"/>
            <a:ext cx="8229600" cy="24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3360240"/>
            <a:ext cx="401580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3360240"/>
            <a:ext cx="4015800" cy="9504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8324640"/>
            <a:ext cx="401580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B99701-D9EB-49EE-99DE-9EC209C82B0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576000"/>
            <a:ext cx="8229600" cy="24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3360240"/>
            <a:ext cx="4015800" cy="9504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3360240"/>
            <a:ext cx="401580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8324640"/>
            <a:ext cx="401580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EF81DB-2DDC-4DA7-BC44-E2468730E4B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576000"/>
            <a:ext cx="8229600" cy="24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3360240"/>
            <a:ext cx="401580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3360240"/>
            <a:ext cx="401580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8324640"/>
            <a:ext cx="822960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771DCE-EAA2-4A52-B620-A0FDCF35846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576000"/>
            <a:ext cx="8229600" cy="24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3360240"/>
            <a:ext cx="8229600" cy="9504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13347720"/>
            <a:ext cx="2133720" cy="76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13347720"/>
            <a:ext cx="2895840" cy="76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13347720"/>
            <a:ext cx="2133720" cy="76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DD713DB-9EEE-4A9B-9D02-81AB1D688CD1}" type="slidenum">
              <a:rPr b="0" lang="zh-TW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971640" y="2160720"/>
          <a:ext cx="6985080" cy="2016000"/>
        </p:xfrm>
        <a:graphic>
          <a:graphicData uri="http://schemas.openxmlformats.org/drawingml/2006/table">
            <a:tbl>
              <a:tblPr/>
              <a:tblGrid>
                <a:gridCol w="2327040"/>
                <a:gridCol w="4658040"/>
              </a:tblGrid>
              <a:tr h="40320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rimer 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equence(5’</a:t>
                      </a: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Wingdings"/>
                          <a:ea typeface="Wingdings"/>
                        </a:rPr>
                        <a:t></a:t>
                      </a: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’)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0320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1640/+460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TAgCTAgCTgCATCTAgTCCTgACTCCggTACC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0320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920/+460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TAgCTAgCgAAAAgTAgAAAgggACgAgTTCCC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0320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260/+460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TAgCTAgCgTTTgTTTgTCTTAATTTTAATTTC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0320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everse(from+460)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CCAAgCTTTCTgCACgACCgCCTCTCTCgCACT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文字方塊 8"/>
          <p:cNvSpPr/>
          <p:nvPr/>
        </p:nvSpPr>
        <p:spPr>
          <a:xfrm>
            <a:off x="971640" y="1440000"/>
            <a:ext cx="76327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Table S2.  Primers used for amplification of different fragments of p27 gene promoter from p27PF plasmid.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694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5-23T06:15:08Z</dcterms:created>
  <dc:creator>Tchan</dc:creator>
  <dc:description/>
  <dc:language>en-US</dc:language>
  <cp:lastModifiedBy>YJ Lee</cp:lastModifiedBy>
  <dcterms:modified xsi:type="dcterms:W3CDTF">2017-03-12T18:23:29Z</dcterms:modified>
  <cp:revision>1072</cp:revision>
  <dc:subject/>
  <dc:title>投影片 1</dc:title>
</cp:coreProperties>
</file>